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42F515-DD4F-48A3-8FD8-7BC95D572A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470E6-78AC-4904-8F7D-DBAFD1805B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FCD648-108B-40B1-893C-A6920A27AF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52628-CFF5-47BC-A715-39D9EAF0F9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179B28-9B53-4873-B794-7B4D4EE98F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021B9E-662C-4563-99B4-1EB844131E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B52BCA-91AF-4E51-B26D-0B7400B470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AEEE73-4213-479E-9129-E2F20ABC0F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0CB9A6-06C6-4484-8A91-BAA980246B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1C2FC-4193-4F05-B65A-53304F6386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6DCA3-4963-4866-BEB9-F2CB283F00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B301F3-99A8-4D08-AFEE-A2B6E07D4E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40329F-F2CA-40AE-BA95-F5866D396BB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package" Target="../embeddings/oleObject1.xlsx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854440" y="5396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909720" y="43560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1628640" y="4356000"/>
            <a:ext cx="4465440" cy="3351240"/>
            <a:chOff x="1628640" y="4356000"/>
            <a:chExt cx="4465440" cy="3351240"/>
          </a:xfrm>
        </p:grpSpPr>
        <p:pic>
          <p:nvPicPr>
            <p:cNvPr id="44" name="" descr=""/>
            <p:cNvPicPr/>
            <p:nvPr/>
          </p:nvPicPr>
          <p:blipFill>
            <a:blip r:embed="rId1"/>
            <a:stretch/>
          </p:blipFill>
          <p:spPr>
            <a:xfrm>
              <a:off x="1628640" y="4356000"/>
              <a:ext cx="4465440" cy="3351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"/>
            <p:cNvSpPr/>
            <p:nvPr/>
          </p:nvSpPr>
          <p:spPr>
            <a:xfrm>
              <a:off x="2563560" y="5940360"/>
              <a:ext cx="7779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ffffff"/>
                  </a:solidFill>
                  <a:latin typeface="Arial"/>
                </a:rPr>
                <a:t>WT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219560" y="5940360"/>
              <a:ext cx="7776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2000" spc="-1" strike="noStrike">
                  <a:solidFill>
                    <a:srgbClr val="ffffff"/>
                  </a:solidFill>
                  <a:latin typeface="Arial"/>
                </a:rPr>
                <a:t>pdx1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7" name=""/>
          <p:cNvSpPr/>
          <p:nvPr/>
        </p:nvSpPr>
        <p:spPr>
          <a:xfrm>
            <a:off x="1985760" y="7885080"/>
            <a:ext cx="19152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Length: 8.5</a:t>
            </a:r>
            <a:r>
              <a:rPr b="0" lang="fr-FR" sz="1200" spc="-1" strike="noStrike" u="sng">
                <a:solidFill>
                  <a:srgbClr val="000000"/>
                </a:solidFill>
                <a:uFillTx/>
                <a:latin typeface="Arial"/>
              </a:rPr>
              <a:t>+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0.6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Dry weight: 1.96 mg/pla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293000" y="7885080"/>
            <a:ext cx="10234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.4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5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8 mg/pla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126080" y="802944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Roots: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844640" y="7956720"/>
            <a:ext cx="73080" cy="504720"/>
          </a:xfrm>
          <a:custGeom>
            <a:avLst/>
            <a:gdLst>
              <a:gd name="textAreaLeft" fmla="*/ 46800 w 73080"/>
              <a:gd name="textAreaRight" fmla="*/ 73440 w 73080"/>
              <a:gd name="textAreaTop" fmla="*/ 12960 h 504720"/>
              <a:gd name="textAreaBottom" fmla="*/ 491760 h 504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221000" y="7956720"/>
            <a:ext cx="73080" cy="504720"/>
          </a:xfrm>
          <a:custGeom>
            <a:avLst/>
            <a:gdLst>
              <a:gd name="textAreaLeft" fmla="*/ 46800 w 73080"/>
              <a:gd name="textAreaRight" fmla="*/ 73440 w 73080"/>
              <a:gd name="textAreaTop" fmla="*/ 12960 h 504720"/>
              <a:gd name="textAreaBottom" fmla="*/ 491760 h 504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84120" y="704880"/>
            <a:ext cx="23972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Additional File 1. Effects of the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pdx1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mutation on A) Arabidopsis shoot growth and B) root growth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3284640" y="250920"/>
          <a:ext cx="3314520" cy="3686040"/>
        </p:xfrm>
        <a:graphic>
          <a:graphicData uri="http://schemas.openxmlformats.org/presentationml/2006/ole">
            <p:oleObj progId="Excel.Sheet.12" r:id="rId2" spid="">
              <p:embed/>
              <p:pic>
                <p:nvPicPr>
                  <p:cNvPr id="54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3284640" y="250920"/>
                    <a:ext cx="3314520" cy="3686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02T09:16:48Z</dcterms:created>
  <dc:creator>havaux</dc:creator>
  <dc:description/>
  <dc:language>en-US</dc:language>
  <cp:lastModifiedBy>havaux</cp:lastModifiedBy>
  <dcterms:modified xsi:type="dcterms:W3CDTF">2009-10-27T10:36:57Z</dcterms:modified>
  <cp:revision>17</cp:revision>
  <dc:subject/>
  <dc:title>Diapositive 1</dc:title>
</cp:coreProperties>
</file>